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  <p:sldId id="259" r:id="rId3"/>
  </p:sldIdLst>
  <p:sldSz cx="12192000" cy="6858000"/>
  <p:notesSz cx="6858000" cy="9144000"/>
  <p:custDataLst>
    <p:tags r:id="rId4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10" autoAdjust="0"/>
    <p:restoredTop sz="94660"/>
  </p:normalViewPr>
  <p:slideViewPr>
    <p:cSldViewPr snapToGrid="0">
      <p:cViewPr varScale="1">
        <p:scale>
          <a:sx n="94" d="100"/>
          <a:sy n="94" d="100"/>
        </p:scale>
        <p:origin x="56" y="1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tags" Target="tags/tag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9BE30-01F8-4A5E-B0A7-CFABA220BAEC}" type="datetimeFigureOut">
              <a:rPr lang="zh-CN" altLang="en-US" smtClean="0"/>
              <a:t>2022/11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12C2E9-3D34-4BDD-B25B-AE16FE694E6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9BE30-01F8-4A5E-B0A7-CFABA220BAEC}" type="datetimeFigureOut">
              <a:rPr lang="zh-CN" altLang="en-US" smtClean="0"/>
              <a:t>2022/11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12C2E9-3D34-4BDD-B25B-AE16FE694E6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9BE30-01F8-4A5E-B0A7-CFABA220BAEC}" type="datetimeFigureOut">
              <a:rPr lang="zh-CN" altLang="en-US" smtClean="0"/>
              <a:t>2022/11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12C2E9-3D34-4BDD-B25B-AE16FE694E6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9BE30-01F8-4A5E-B0A7-CFABA220BAEC}" type="datetimeFigureOut">
              <a:rPr lang="zh-CN" altLang="en-US" smtClean="0"/>
              <a:t>2022/11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12C2E9-3D34-4BDD-B25B-AE16FE694E6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9BE30-01F8-4A5E-B0A7-CFABA220BAEC}" type="datetimeFigureOut">
              <a:rPr lang="zh-CN" altLang="en-US" smtClean="0"/>
              <a:t>2022/11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12C2E9-3D34-4BDD-B25B-AE16FE694E6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9BE30-01F8-4A5E-B0A7-CFABA220BAEC}" type="datetimeFigureOut">
              <a:rPr lang="zh-CN" altLang="en-US" smtClean="0"/>
              <a:t>2022/11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12C2E9-3D34-4BDD-B25B-AE16FE694E6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9BE30-01F8-4A5E-B0A7-CFABA220BAEC}" type="datetimeFigureOut">
              <a:rPr lang="zh-CN" altLang="en-US" smtClean="0"/>
              <a:t>2022/11/2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12C2E9-3D34-4BDD-B25B-AE16FE694E6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9BE30-01F8-4A5E-B0A7-CFABA220BAEC}" type="datetimeFigureOut">
              <a:rPr lang="zh-CN" altLang="en-US" smtClean="0"/>
              <a:t>2022/11/2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12C2E9-3D34-4BDD-B25B-AE16FE694E6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9BE30-01F8-4A5E-B0A7-CFABA220BAEC}" type="datetimeFigureOut">
              <a:rPr lang="zh-CN" altLang="en-US" smtClean="0"/>
              <a:t>2022/11/2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12C2E9-3D34-4BDD-B25B-AE16FE694E6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9BE30-01F8-4A5E-B0A7-CFABA220BAEC}" type="datetimeFigureOut">
              <a:rPr lang="zh-CN" altLang="en-US" smtClean="0"/>
              <a:t>2022/11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12C2E9-3D34-4BDD-B25B-AE16FE694E6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9BE30-01F8-4A5E-B0A7-CFABA220BAEC}" type="datetimeFigureOut">
              <a:rPr lang="zh-CN" altLang="en-US" smtClean="0"/>
              <a:t>2022/11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12C2E9-3D34-4BDD-B25B-AE16FE694E6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69BE30-01F8-4A5E-B0A7-CFABA220BAEC}" type="datetimeFigureOut">
              <a:rPr lang="zh-CN" altLang="en-US" smtClean="0"/>
              <a:t>2022/11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12C2E9-3D34-4BDD-B25B-AE16FE694E6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9D716B66-39BA-3C4F-8489-09D019B011D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-40640"/>
            <a:ext cx="12192000" cy="6858000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2"/>
          <p:cNvSpPr txBox="1"/>
          <p:nvPr/>
        </p:nvSpPr>
        <p:spPr>
          <a:xfrm>
            <a:off x="1466850" y="969910"/>
            <a:ext cx="9258300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 algn="just">
              <a:defRPr/>
            </a:pPr>
            <a:r>
              <a:rPr kumimoji="0" lang="en-US" altLang="zh-CN" sz="18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+mn-cs"/>
              </a:rPr>
              <a:t>Figure S1</a:t>
            </a:r>
            <a:r>
              <a:rPr lang="en-US" altLang="zh-CN" b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.</a:t>
            </a:r>
            <a:r>
              <a:rPr kumimoji="0" lang="en-US" altLang="zh-CN" sz="18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+mn-cs"/>
              </a:rPr>
              <a:t>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Flowchart of patient screening process. ICI </a:t>
            </a:r>
            <a:r>
              <a:rPr lang="en-US" altLang="zh-CN" dirty="0">
                <a:latin typeface="Times New Roman" panose="02020603050405020304" pitchFamily="18" charset="0"/>
              </a:rPr>
              <a:t>indicates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immune-checkpoint inhibitor; RECIST, Response Evaluation Criteria in Solid Tumors; SCLC</a:t>
            </a:r>
            <a:r>
              <a:rPr lang="en-US" altLang="zh-CN" dirty="0">
                <a:latin typeface="Times New Roman" panose="02020603050405020304" pitchFamily="18" charset="0"/>
                <a:ea typeface="等线" panose="02010600030101010101" pitchFamily="2" charset="-122"/>
              </a:rPr>
              <a:t>,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small cell lung cancer; SYSUCC, Sun </a:t>
            </a:r>
            <a:r>
              <a:rPr lang="en-US" altLang="zh-CN" sz="18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Yat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-Sen University Cancer Center; TGR, tumor growth rate.</a:t>
            </a:r>
            <a:endParaRPr kumimoji="0" lang="zh-CN" altLang="zh-CN" sz="32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+mn-cs"/>
            </a:endParaRPr>
          </a:p>
        </p:txBody>
      </p: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ZjcyY2ZlMjlhZDU5NDNkZDg3MTQ2MTQ1OGQ5NmVlYTkifQ==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44</Words>
  <Application>Microsoft Office PowerPoint</Application>
  <PresentationFormat>宽屏</PresentationFormat>
  <Paragraphs>1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陈 巷</dc:creator>
  <cp:lastModifiedBy>陈 巷</cp:lastModifiedBy>
  <cp:revision>8</cp:revision>
  <dcterms:created xsi:type="dcterms:W3CDTF">2022-08-30T14:54:00Z</dcterms:created>
  <dcterms:modified xsi:type="dcterms:W3CDTF">2022-11-28T13:34:3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06BE8EFFB8194B63838751640D16A309</vt:lpwstr>
  </property>
  <property fmtid="{D5CDD505-2E9C-101B-9397-08002B2CF9AE}" pid="3" name="KSOProductBuildVer">
    <vt:lpwstr>2052-11.1.0.12651</vt:lpwstr>
  </property>
</Properties>
</file>